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501" autoAdjust="0"/>
    <p:restoredTop sz="94660"/>
  </p:normalViewPr>
  <p:slideViewPr>
    <p:cSldViewPr snapToGrid="0">
      <p:cViewPr>
        <p:scale>
          <a:sx n="125" d="100"/>
          <a:sy n="125" d="100"/>
        </p:scale>
        <p:origin x="2790" y="-3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590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141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698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46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784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91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47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918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641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431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349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643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Εικόνα 17" descr="Εικόνα που περιέχει στιγμιότυπο οθόνης, λογισμικό πολυμέσων&#10;&#10;Περιγραφή που δημιουργήθηκε αυτόματα">
            <a:extLst>
              <a:ext uri="{FF2B5EF4-FFF2-40B4-BE49-F238E27FC236}">
                <a16:creationId xmlns:a16="http://schemas.microsoft.com/office/drawing/2014/main" id="{8B7B742F-82AF-A8A1-AF74-27DFC5244C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258" y="4953000"/>
            <a:ext cx="5167484" cy="236916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9C5C4C6-BA29-AC44-82E9-BAF02BE74E2D}"/>
              </a:ext>
            </a:extLst>
          </p:cNvPr>
          <p:cNvSpPr txBox="1"/>
          <p:nvPr/>
        </p:nvSpPr>
        <p:spPr>
          <a:xfrm>
            <a:off x="58084" y="4467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FE7291-81DF-7793-0133-2B50873B3125}"/>
              </a:ext>
            </a:extLst>
          </p:cNvPr>
          <p:cNvSpPr txBox="1"/>
          <p:nvPr/>
        </p:nvSpPr>
        <p:spPr>
          <a:xfrm>
            <a:off x="3700003" y="44675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D692528-56E4-2C2C-88A7-C91A04489984}"/>
              </a:ext>
            </a:extLst>
          </p:cNvPr>
          <p:cNvSpPr txBox="1"/>
          <p:nvPr/>
        </p:nvSpPr>
        <p:spPr>
          <a:xfrm>
            <a:off x="1739025" y="481793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3D3E615-25AD-5EC6-5B9C-8CC4C4AB0B0A}"/>
              </a:ext>
            </a:extLst>
          </p:cNvPr>
          <p:cNvSpPr txBox="1"/>
          <p:nvPr/>
        </p:nvSpPr>
        <p:spPr>
          <a:xfrm>
            <a:off x="272245" y="8173944"/>
            <a:ext cx="625809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enrichment analysis of DEGs related to root tissue identified through microarray meta-analysis in the context of drought. A) Top 20 enriched Gene Ontology (GO) terms for Biological Processes identified using STRING; B) Seven enriched GO terms for Molecular Functions identified using STRING; C) Top 20 enriched GO terms for Cellular Components identified using STRING; D) Top KEGG enriched terms identified using STRING. All graphs are displayed with the x-axis representing strength and the y-axis representing the enriched terms.</a:t>
            </a:r>
          </a:p>
        </p:txBody>
      </p:sp>
      <p:pic>
        <p:nvPicPr>
          <p:cNvPr id="4" name="Εικόνα 3" descr="Εικόνα που περιέχει στιγμιότυπο οθόνης, κείμενο&#10;&#10;Περιγραφή που δημιουργήθηκε αυτόματα">
            <a:extLst>
              <a:ext uri="{FF2B5EF4-FFF2-40B4-BE49-F238E27FC236}">
                <a16:creationId xmlns:a16="http://schemas.microsoft.com/office/drawing/2014/main" id="{A3269AAB-638C-CF5B-28D2-661889F4795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84" y="816090"/>
            <a:ext cx="3361882" cy="3713751"/>
          </a:xfrm>
          <a:prstGeom prst="rect">
            <a:avLst/>
          </a:prstGeom>
        </p:spPr>
      </p:pic>
      <p:pic>
        <p:nvPicPr>
          <p:cNvPr id="8" name="Εικόνα 7" descr="Εικόνα που περιέχει στιγμιότυπο οθόνης, κείμενο&#10;&#10;Περιγραφή που δημιουργήθηκε αυτόματα">
            <a:extLst>
              <a:ext uri="{FF2B5EF4-FFF2-40B4-BE49-F238E27FC236}">
                <a16:creationId xmlns:a16="http://schemas.microsoft.com/office/drawing/2014/main" id="{0D9A5179-9C45-3DF1-668C-8E714EE12F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8034" y="816090"/>
            <a:ext cx="3361882" cy="37137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5944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</TotalTime>
  <Words>101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MPA MARIA</dc:creator>
  <cp:lastModifiedBy>KAMPA MARIA</cp:lastModifiedBy>
  <cp:revision>20</cp:revision>
  <dcterms:created xsi:type="dcterms:W3CDTF">2025-01-13T16:07:29Z</dcterms:created>
  <dcterms:modified xsi:type="dcterms:W3CDTF">2025-07-16T04:24:29Z</dcterms:modified>
</cp:coreProperties>
</file>